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69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015" autoAdjust="0"/>
    <p:restoredTop sz="80062"/>
  </p:normalViewPr>
  <p:slideViewPr>
    <p:cSldViewPr snapToGrid="0" snapToObjects="1">
      <p:cViewPr varScale="1">
        <p:scale>
          <a:sx n="85" d="100"/>
          <a:sy n="85" d="100"/>
        </p:scale>
        <p:origin x="-272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20B4F-419C-914F-8D8C-068A43549A3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AA33D8-C132-3F44-82EC-6FC4CA8054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82610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9C4681-39C4-3B4D-9204-BD06B6CAA7B4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BF9D42-348E-484A-8D7A-21D6BE55715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03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BF9D42-348E-484A-8D7A-21D6BE55715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4923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5408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7887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4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09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187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59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18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0260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4235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913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52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5F9DC-0092-004C-8ACB-90EBC80C987B}" type="datetimeFigureOut">
              <a:rPr kumimoji="1" lang="ja-JP" altLang="en-US" smtClean="0"/>
              <a:t>2020/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3827DC-3666-7A4B-BCDE-0637894170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320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4">
            <a:extLst>
              <a:ext uri="{FF2B5EF4-FFF2-40B4-BE49-F238E27FC236}">
                <a16:creationId xmlns="" xmlns:a16="http://schemas.microsoft.com/office/drawing/2014/main" id="{DA3AED8D-5E47-F746-94BB-3D833DE832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2991" y="817794"/>
            <a:ext cx="57320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/>
            <a:r>
              <a:rPr lang="en-US" altLang="ja-JP" sz="1200" b="1" dirty="0">
                <a:latin typeface="Times New Roman" panose="02020603050405020304" pitchFamily="18" charset="0"/>
              </a:rPr>
              <a:t>S3 Table.  Taxonomical characterization of </a:t>
            </a:r>
            <a:r>
              <a:rPr lang="en-US" altLang="ja-JP" sz="1200" b="1" i="1" dirty="0">
                <a:latin typeface="Times New Roman" panose="02020603050405020304" pitchFamily="18" charset="0"/>
              </a:rPr>
              <a:t>L. plantarum </a:t>
            </a:r>
            <a:r>
              <a:rPr lang="en-US" altLang="ja-JP" sz="1200" b="1" dirty="0">
                <a:latin typeface="Times New Roman" panose="02020603050405020304" pitchFamily="18" charset="0"/>
              </a:rPr>
              <a:t>P1-2 and </a:t>
            </a:r>
            <a:r>
              <a:rPr lang="en-US" altLang="ja-JP" sz="1200" b="1" i="1" dirty="0">
                <a:latin typeface="Times New Roman" panose="02020603050405020304" pitchFamily="18" charset="0"/>
              </a:rPr>
              <a:t>P. pentosaceus</a:t>
            </a:r>
            <a:r>
              <a:rPr lang="en-US" altLang="ja-JP" sz="1200" b="1" dirty="0">
                <a:latin typeface="Times New Roman" panose="02020603050405020304" pitchFamily="18" charset="0"/>
              </a:rPr>
              <a:t> Be1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="" xmlns:a16="http://schemas.microsoft.com/office/drawing/2014/main" id="{C1AC2F1F-261E-3244-877F-253F3D0025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3927985"/>
              </p:ext>
            </p:extLst>
          </p:nvPr>
        </p:nvGraphicFramePr>
        <p:xfrm>
          <a:off x="1773260" y="1166496"/>
          <a:ext cx="3487980" cy="5760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768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1210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1473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73468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396240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in nam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obacillu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ntarum </a:t>
                      </a:r>
                      <a:r>
                        <a:rPr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-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diococcus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i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ntosaceus</a:t>
                      </a:r>
                      <a:r>
                        <a:rPr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Be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Form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od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cci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s from Gluc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ala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43840">
                <a:tc row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rowth Temperatur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r>
                        <a:rPr kumimoji="1" lang="ja-JP" altLang="en-US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r>
                        <a:rPr kumimoji="1" lang="ja-JP" altLang="en-US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r>
                        <a:rPr kumimoji="1" lang="ja-JP" altLang="en-US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</a:t>
                      </a:r>
                      <a:r>
                        <a:rPr kumimoji="1" lang="ja-JP" altLang="en-US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℃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43840">
                <a:tc rowSpan="1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gar Fermentation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vert="eaVert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-arabin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-rib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-xyl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uct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n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r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hal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ffin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hamnos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7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nnitol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8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rbitol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9"/>
                  </a:ext>
                </a:extLst>
              </a:tr>
              <a:tr h="24384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-gluconat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0"/>
                  </a:ext>
                </a:extLst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P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1"/>
                  </a:ext>
                </a:extLst>
              </a:tr>
              <a:tr h="243840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ate Rotate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2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60325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7F7F7F"/>
        </a:solidFill>
        <a:ln w="1588" cap="flat">
          <a:solidFill>
            <a:srgbClr val="7F7F7F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algn="l">
          <a:defRPr sz="1000"/>
        </a:defPPr>
      </a:lstStyle>
    </a:spDef>
  </a:objectDefaults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</TotalTime>
  <Words>102</Words>
  <Application>Microsoft Office PowerPoint</Application>
  <PresentationFormat>On-screen Show (4:3)</PresentationFormat>
  <Paragraphs>7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200588</dc:creator>
  <cp:lastModifiedBy>Arshad Rezwan</cp:lastModifiedBy>
  <cp:revision>67</cp:revision>
  <cp:lastPrinted>2019-06-09T14:07:56Z</cp:lastPrinted>
  <dcterms:created xsi:type="dcterms:W3CDTF">2019-02-21T04:56:07Z</dcterms:created>
  <dcterms:modified xsi:type="dcterms:W3CDTF">2020-02-14T11:13:38Z</dcterms:modified>
</cp:coreProperties>
</file>